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 showGuides="1">
      <p:cViewPr varScale="1">
        <p:scale>
          <a:sx n="65" d="100"/>
          <a:sy n="65" d="100"/>
        </p:scale>
        <p:origin x="1334" y="29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27774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77995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131544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492593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41977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27842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99722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70442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057783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687729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7023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B18470-C2F5-4255-A88B-B6107D7842E0}" type="datetimeFigureOut">
              <a:rPr lang="es-MX" smtClean="0"/>
              <a:t>16/07/2019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9386C-0A8C-4E75-BD5D-969E33C5F4B3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62047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ángulo 5">
            <a:extLst>
              <a:ext uri="{FF2B5EF4-FFF2-40B4-BE49-F238E27FC236}">
                <a16:creationId xmlns:a16="http://schemas.microsoft.com/office/drawing/2014/main" id="{B8BA21E6-15EB-480D-B22B-62A84817F34C}"/>
              </a:ext>
            </a:extLst>
          </p:cNvPr>
          <p:cNvSpPr/>
          <p:nvPr/>
        </p:nvSpPr>
        <p:spPr>
          <a:xfrm>
            <a:off x="808751" y="5684246"/>
            <a:ext cx="752649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Histopathological analyses of organs obtained after mid-laparotomy in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/Nu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 treated with gallic acid and myricetin.</a:t>
            </a:r>
            <a:endParaRPr lang="es-MX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sections of kidneys, heart, lungs, spleen and liver are shown at 10X magnification, to discard tissue lesions caused by the treatments (50 mg/kg in 2 alternate days per week, 4 weeks, peritumoral route). Results are representative of two biological replicates (n = 5).</a:t>
            </a:r>
            <a:endParaRPr lang="es-MX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2" name="Imagen 11">
            <a:extLst>
              <a:ext uri="{FF2B5EF4-FFF2-40B4-BE49-F238E27FC236}">
                <a16:creationId xmlns:a16="http://schemas.microsoft.com/office/drawing/2014/main" id="{B7569099-81C4-447B-A660-D5502D2477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8910" b="1339"/>
          <a:stretch/>
        </p:blipFill>
        <p:spPr>
          <a:xfrm>
            <a:off x="808751" y="82069"/>
            <a:ext cx="7526496" cy="5574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755658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78</Words>
  <Application>Microsoft Office PowerPoint</Application>
  <PresentationFormat>Presentación en pantalla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is Varela Rodriguez</dc:creator>
  <cp:lastModifiedBy>Luis Varela Rodriguez</cp:lastModifiedBy>
  <cp:revision>3</cp:revision>
  <dcterms:created xsi:type="dcterms:W3CDTF">2019-06-20T19:26:14Z</dcterms:created>
  <dcterms:modified xsi:type="dcterms:W3CDTF">2019-07-17T02:24:02Z</dcterms:modified>
</cp:coreProperties>
</file>